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wmf" ContentType="image/x-wmf"/>
  <Override PartName="/ppt/media/image31.png" ContentType="image/png"/>
  <Override PartName="/ppt/media/image18.wmf" ContentType="image/x-wmf"/>
  <Override PartName="/ppt/media/image20.wmf" ContentType="image/x-wmf"/>
  <Override PartName="/ppt/media/image5.jpeg" ContentType="image/jpeg"/>
  <Override PartName="/ppt/media/image11.wmf" ContentType="image/x-wmf"/>
  <Override PartName="/ppt/media/image3.png" ContentType="image/png"/>
  <Override PartName="/ppt/media/image9.wmf" ContentType="image/x-wmf"/>
  <Override PartName="/ppt/media/image4.png" ContentType="image/png"/>
  <Override PartName="/ppt/media/image12.wmf" ContentType="image/x-wmf"/>
  <Override PartName="/ppt/media/image7.wmf" ContentType="image/x-wmf"/>
  <Override PartName="/ppt/media/image8.wmf" ContentType="image/x-wmf"/>
  <Override PartName="/ppt/media/image13.wmf" ContentType="image/x-wmf"/>
  <Override PartName="/ppt/media/image10.wmf" ContentType="image/x-wmf"/>
  <Override PartName="/ppt/media/image2.png" ContentType="image/png"/>
  <Override PartName="/ppt/media/image30.wmf" ContentType="image/x-wmf"/>
  <Override PartName="/ppt/media/image28.png" ContentType="image/png"/>
  <Override PartName="/ppt/media/image1.wmf" ContentType="image/x-wmf"/>
  <Override PartName="/ppt/media/image24.wmf" ContentType="image/x-wmf"/>
  <Override PartName="/ppt/media/image14.wmf" ContentType="image/x-wmf"/>
  <Override PartName="/ppt/media/image15.wmf" ContentType="image/x-wmf"/>
  <Override PartName="/ppt/media/image16.wmf" ContentType="image/x-wmf"/>
  <Override PartName="/ppt/media/image17.wmf" ContentType="image/x-wmf"/>
  <Override PartName="/ppt/media/image19.wmf" ContentType="image/x-wmf"/>
  <Override PartName="/ppt/media/image6.jpeg" ContentType="image/jpeg"/>
  <Override PartName="/ppt/media/image21.wmf" ContentType="image/x-wmf"/>
  <Override PartName="/ppt/media/image22.wmf" ContentType="image/x-wmf"/>
  <Override PartName="/ppt/media/image23.png" ContentType="image/png"/>
  <Override PartName="/ppt/media/image25.wmf" ContentType="image/x-wmf"/>
  <Override PartName="/ppt/media/image26.wmf" ContentType="image/x-wmf"/>
  <Override PartName="/ppt/media/image27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26.xml" ContentType="application/vnd.openxmlformats-officedocument.presentationml.slide+xml"/>
  <Override PartName="/ppt/slides/slide14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slide16.xml" ContentType="application/vnd.openxmlformats-officedocument.presentationml.slide+xml"/>
  <Override PartName="/ppt/slides/slide1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ABDA31-C0E7-4019-A90A-19B0B2CCF47C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5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I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6ADC00-C98B-431B-8B66-8BF47B49CD3B}" type="slidenum">
              <a:rPr b="0" lang="en-IN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E9698-7068-4FAC-8C6C-973B8225B8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51683-7B75-4DD4-9832-4794E543AC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17C612-DA8C-4F6B-B24F-1B674726A7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007D9-D57D-4CCE-9DB4-4E372EC9DA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677BC-3084-46D8-A19D-4DBFA770E8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523B07-730C-421E-8B59-6B3E816534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B7A52-2B20-4A5D-8C8D-D233EA7A60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DDA16-121A-4461-A5F2-7E6E613A82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202D1-1307-4AF8-9C82-739CD49809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73E622-1C0E-49B1-BFCE-5E46066760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83F83-2834-4A2D-A2FA-B0ABBAB280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5E358-E630-401B-AE42-EE7D525E19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F0877A-0EBE-4C54-8AE6-F83196405967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image" Target="../media/image17.wmf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image" Target="../media/image20.wmf"/><Relationship Id="rId3" Type="http://schemas.openxmlformats.org/officeDocument/2006/relationships/image" Target="../media/image21.wmf"/><Relationship Id="rId4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2.wmf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24.wmf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25.wmf"/><Relationship Id="rId2" Type="http://schemas.openxmlformats.org/officeDocument/2006/relationships/image" Target="../media/image26.wmf"/><Relationship Id="rId3" Type="http://schemas.openxmlformats.org/officeDocument/2006/relationships/image" Target="../media/image27.wmf"/><Relationship Id="rId4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9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30.wmf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jpeg"/><Relationship Id="rId3" Type="http://schemas.openxmlformats.org/officeDocument/2006/relationships/image" Target="../media/image6.jpe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image" Target="../media/image12.wmf"/><Relationship Id="rId3" Type="http://schemas.openxmlformats.org/officeDocument/2006/relationships/image" Target="../media/image13.wmf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93" descr=""/>
          <p:cNvPicPr/>
          <p:nvPr/>
        </p:nvPicPr>
        <p:blipFill>
          <a:blip r:embed="rId1"/>
          <a:stretch/>
        </p:blipFill>
        <p:spPr>
          <a:xfrm>
            <a:off x="0" y="1413000"/>
            <a:ext cx="8459640" cy="3960720"/>
          </a:xfrm>
          <a:prstGeom prst="rect">
            <a:avLst/>
          </a:prstGeom>
          <a:ln w="0">
            <a:noFill/>
          </a:ln>
        </p:spPr>
      </p:pic>
      <p:sp>
        <p:nvSpPr>
          <p:cNvPr id="49" name="TextBox 2"/>
          <p:cNvSpPr/>
          <p:nvPr/>
        </p:nvSpPr>
        <p:spPr>
          <a:xfrm>
            <a:off x="611280" y="5516640"/>
            <a:ext cx="784836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S:      Agarose gel electrophoretograms indicating the pattern of isoforms in liver and respective blood sample of a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1: Wild-OCT1 (200bp); Lane-2: Isoform-1 (151bp); Lane-3: Isoform-2 (72bp); Lane-4: Isoform-3 (345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1ʹ: Wild-OCT1 (200bp); Lane-2ʹ: Isoform-1 (151bp); Lane-3ʹ: Isoform-2 (72bp); Lane-4ʹ: Isoform-3 (345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M: DNA marker (100bp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94"/>
          <p:cNvSpPr/>
          <p:nvPr/>
        </p:nvSpPr>
        <p:spPr>
          <a:xfrm>
            <a:off x="0" y="1413000"/>
            <a:ext cx="8459640" cy="396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Picture 2" descr=""/>
          <p:cNvPicPr/>
          <p:nvPr/>
        </p:nvPicPr>
        <p:blipFill>
          <a:blip r:embed="rId1"/>
          <a:stretch/>
        </p:blipFill>
        <p:spPr>
          <a:xfrm>
            <a:off x="611280" y="1268280"/>
            <a:ext cx="8281800" cy="4176720"/>
          </a:xfrm>
          <a:prstGeom prst="rect">
            <a:avLst/>
          </a:prstGeom>
          <a:ln w="0">
            <a:noFill/>
          </a:ln>
        </p:spPr>
      </p:pic>
      <p:sp>
        <p:nvSpPr>
          <p:cNvPr id="94" name="TextBox 2"/>
          <p:cNvSpPr/>
          <p:nvPr/>
        </p:nvSpPr>
        <p:spPr>
          <a:xfrm>
            <a:off x="395280" y="5589720"/>
            <a:ext cx="82090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8S: F. The three clusters (yellow dotted circles) formed by docking complexes with a favourab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nergy scor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Oval 4"/>
          <p:cNvSpPr/>
          <p:nvPr/>
        </p:nvSpPr>
        <p:spPr>
          <a:xfrm>
            <a:off x="2050920" y="1989000"/>
            <a:ext cx="962280" cy="898560"/>
          </a:xfrm>
          <a:prstGeom prst="ellipse">
            <a:avLst/>
          </a:prstGeom>
          <a:noFill/>
          <a:ln w="12600">
            <a:solidFill>
              <a:srgbClr val="ffff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Group 9"/>
          <p:cNvGrpSpPr/>
          <p:nvPr/>
        </p:nvGrpSpPr>
        <p:grpSpPr>
          <a:xfrm>
            <a:off x="755640" y="1916280"/>
            <a:ext cx="10369440" cy="3009600"/>
            <a:chOff x="755640" y="1916280"/>
            <a:chExt cx="10369440" cy="3009600"/>
          </a:xfrm>
        </p:grpSpPr>
        <p:grpSp>
          <p:nvGrpSpPr>
            <p:cNvPr id="97" name="Group 7"/>
            <p:cNvGrpSpPr/>
            <p:nvPr/>
          </p:nvGrpSpPr>
          <p:grpSpPr>
            <a:xfrm>
              <a:off x="755640" y="1916280"/>
              <a:ext cx="10369440" cy="3009600"/>
              <a:chOff x="755640" y="1916280"/>
              <a:chExt cx="10369440" cy="3009600"/>
            </a:xfrm>
          </p:grpSpPr>
          <p:pic>
            <p:nvPicPr>
              <p:cNvPr id="98" name="Picture 3" descr=""/>
              <p:cNvPicPr/>
              <p:nvPr/>
            </p:nvPicPr>
            <p:blipFill>
              <a:blip r:embed="rId1"/>
              <a:stretch/>
            </p:blipFill>
            <p:spPr>
              <a:xfrm>
                <a:off x="755640" y="1916280"/>
                <a:ext cx="6337080" cy="300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9" name="Picture 5" descr=""/>
              <p:cNvPicPr/>
              <p:nvPr/>
            </p:nvPicPr>
            <p:blipFill>
              <a:blip r:embed="rId2"/>
              <a:stretch/>
            </p:blipFill>
            <p:spPr>
              <a:xfrm>
                <a:off x="4716000" y="1916280"/>
                <a:ext cx="6409080" cy="30049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00" name="Oval 6"/>
            <p:cNvSpPr/>
            <p:nvPr/>
          </p:nvSpPr>
          <p:spPr>
            <a:xfrm>
              <a:off x="2051640" y="1916280"/>
              <a:ext cx="961920" cy="898200"/>
            </a:xfrm>
            <a:prstGeom prst="ellipse">
              <a:avLst/>
            </a:prstGeom>
            <a:noFill/>
            <a:ln w="12600">
              <a:solidFill>
                <a:srgbClr val="ffff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TextBox 8"/>
          <p:cNvSpPr/>
          <p:nvPr/>
        </p:nvSpPr>
        <p:spPr>
          <a:xfrm>
            <a:off x="611280" y="4941720"/>
            <a:ext cx="720072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8S: G. Cluster 1 showing interaction of metformin with the amino acids Arginine 61, Glutamine 60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 Tyrosine 256 (extracellular region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. Magnified view of cluster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Picture 2" descr=""/>
          <p:cNvPicPr/>
          <p:nvPr/>
        </p:nvPicPr>
        <p:blipFill>
          <a:blip r:embed="rId1"/>
          <a:stretch/>
        </p:blipFill>
        <p:spPr>
          <a:xfrm>
            <a:off x="755640" y="2085840"/>
            <a:ext cx="7272360" cy="2998800"/>
          </a:xfrm>
          <a:prstGeom prst="rect">
            <a:avLst/>
          </a:prstGeom>
          <a:ln w="0">
            <a:noFill/>
          </a:ln>
        </p:spPr>
      </p:pic>
      <p:sp>
        <p:nvSpPr>
          <p:cNvPr id="103" name="TextBox 2"/>
          <p:cNvSpPr/>
          <p:nvPr/>
        </p:nvSpPr>
        <p:spPr>
          <a:xfrm>
            <a:off x="1258920" y="5229360"/>
            <a:ext cx="727236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8S: I. Cluster 2 showing interaction of metformin with the amino acids Alanine 257 and Prolin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9 (extracellular region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.  Magnified view of cluster 2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oup 11"/>
          <p:cNvGrpSpPr/>
          <p:nvPr/>
        </p:nvGrpSpPr>
        <p:grpSpPr>
          <a:xfrm>
            <a:off x="468360" y="1952640"/>
            <a:ext cx="9683640" cy="3348000"/>
            <a:chOff x="468360" y="1952640"/>
            <a:chExt cx="9683640" cy="3348000"/>
          </a:xfrm>
        </p:grpSpPr>
        <p:pic>
          <p:nvPicPr>
            <p:cNvPr id="105" name="Picture 5" descr=""/>
            <p:cNvPicPr/>
            <p:nvPr/>
          </p:nvPicPr>
          <p:blipFill>
            <a:blip r:embed="rId1"/>
            <a:stretch/>
          </p:blipFill>
          <p:spPr>
            <a:xfrm>
              <a:off x="468360" y="1952640"/>
              <a:ext cx="6696000" cy="334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Oval 6"/>
            <p:cNvSpPr/>
            <p:nvPr/>
          </p:nvSpPr>
          <p:spPr>
            <a:xfrm>
              <a:off x="1764360" y="2780640"/>
              <a:ext cx="669600" cy="792000"/>
            </a:xfrm>
            <a:prstGeom prst="ellipse">
              <a:avLst/>
            </a:prstGeom>
            <a:noFill/>
            <a:ln w="12600">
              <a:solidFill>
                <a:srgbClr val="ffff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7" name="Picture 9" descr=""/>
            <p:cNvPicPr/>
            <p:nvPr/>
          </p:nvPicPr>
          <p:blipFill>
            <a:blip r:embed="rId2"/>
            <a:stretch/>
          </p:blipFill>
          <p:spPr>
            <a:xfrm>
              <a:off x="3996360" y="4724640"/>
              <a:ext cx="6155640" cy="50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10" descr=""/>
            <p:cNvPicPr/>
            <p:nvPr/>
          </p:nvPicPr>
          <p:blipFill>
            <a:blip r:embed="rId3"/>
            <a:stretch/>
          </p:blipFill>
          <p:spPr>
            <a:xfrm>
              <a:off x="4356360" y="1988640"/>
              <a:ext cx="3024720" cy="30960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9" name="TextBox 6"/>
          <p:cNvSpPr/>
          <p:nvPr/>
        </p:nvSpPr>
        <p:spPr>
          <a:xfrm>
            <a:off x="755640" y="5300640"/>
            <a:ext cx="662472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8S: K. Cluster 3 showing interaction of metformin with the amino acid Glycine 477 and inn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lices of exon-1 and exon-7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: Magnified view of cluster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Picture 2" descr=""/>
          <p:cNvPicPr/>
          <p:nvPr/>
        </p:nvPicPr>
        <p:blipFill>
          <a:blip r:embed="rId1"/>
          <a:stretch/>
        </p:blipFill>
        <p:spPr>
          <a:xfrm>
            <a:off x="0" y="1989000"/>
            <a:ext cx="7343640" cy="2880000"/>
          </a:xfrm>
          <a:prstGeom prst="rect">
            <a:avLst/>
          </a:prstGeom>
          <a:ln w="0">
            <a:noFill/>
          </a:ln>
        </p:spPr>
      </p:pic>
      <p:sp>
        <p:nvSpPr>
          <p:cNvPr id="111" name="TextBox 2"/>
          <p:cNvSpPr/>
          <p:nvPr/>
        </p:nvSpPr>
        <p:spPr>
          <a:xfrm>
            <a:off x="755640" y="4941720"/>
            <a:ext cx="741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9S: Agarose gel electrophoretograms indicating the exon-1 amplicons in patient sample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s 1-8: PCR amplification products of exon-1 (584bp); Lane-M: DNA marker (100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Group 15"/>
          <p:cNvGrpSpPr/>
          <p:nvPr/>
        </p:nvGrpSpPr>
        <p:grpSpPr>
          <a:xfrm>
            <a:off x="2771640" y="2060640"/>
            <a:ext cx="5472360" cy="2663640"/>
            <a:chOff x="2771640" y="2060640"/>
            <a:chExt cx="5472360" cy="2663640"/>
          </a:xfrm>
        </p:grpSpPr>
        <p:pic>
          <p:nvPicPr>
            <p:cNvPr id="113" name="Picture 3" descr="C:\Users\m\Desktop\tlr 4 asp patients.jpg"/>
            <p:cNvPicPr/>
            <p:nvPr/>
          </p:nvPicPr>
          <p:blipFill>
            <a:blip r:embed="rId1"/>
            <a:srcRect l="0" t="0" r="10922" b="6256"/>
            <a:stretch/>
          </p:blipFill>
          <p:spPr>
            <a:xfrm>
              <a:off x="2843640" y="2492640"/>
              <a:ext cx="4176360" cy="223164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114" name="Rectangle 4"/>
            <p:cNvSpPr/>
            <p:nvPr/>
          </p:nvSpPr>
          <p:spPr>
            <a:xfrm>
              <a:off x="2771640" y="2060640"/>
              <a:ext cx="4320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</a:t>
              </a:r>
              <a:r>
                <a:rPr b="1" lang="en-IN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      1       2       3        4        5     6       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5" name="AutoShape 4"/>
            <p:cNvCxnSpPr/>
            <p:nvPr/>
          </p:nvCxnSpPr>
          <p:spPr>
            <a:xfrm>
              <a:off x="6876000" y="4147920"/>
              <a:ext cx="57636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16" name="TextBox 11"/>
            <p:cNvSpPr/>
            <p:nvPr/>
          </p:nvSpPr>
          <p:spPr>
            <a:xfrm>
              <a:off x="7452000" y="4004280"/>
              <a:ext cx="792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N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76b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TextBox 6"/>
          <p:cNvSpPr/>
          <p:nvPr/>
        </p:nvSpPr>
        <p:spPr>
          <a:xfrm>
            <a:off x="1116000" y="4869000"/>
            <a:ext cx="67690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0S: Agarose gel electrophoretograms indicating  the exon-7 amplicons in patient sample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s 1-7: PCR amplification products of exon-7 (276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M: DNA marker (100bp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Picture 1" descr=""/>
          <p:cNvPicPr/>
          <p:nvPr/>
        </p:nvPicPr>
        <p:blipFill>
          <a:blip r:embed="rId1"/>
          <a:srcRect l="0" t="6824" r="0" b="0"/>
          <a:stretch/>
        </p:blipFill>
        <p:spPr>
          <a:xfrm>
            <a:off x="1187280" y="549360"/>
            <a:ext cx="7056720" cy="3887640"/>
          </a:xfrm>
          <a:prstGeom prst="rect">
            <a:avLst/>
          </a:prstGeom>
          <a:ln w="0">
            <a:noFill/>
          </a:ln>
        </p:spPr>
      </p:pic>
      <p:sp>
        <p:nvSpPr>
          <p:cNvPr id="119" name="TextBox 2"/>
          <p:cNvSpPr/>
          <p:nvPr/>
        </p:nvSpPr>
        <p:spPr>
          <a:xfrm>
            <a:off x="1116000" y="4797360"/>
            <a:ext cx="734364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1S: A.  Partial electropherogram of 156 T&gt;C (exon-1) change showing heterozygous TC and wild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 genotyp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 Partial electropherogram of 181 C&gt;T (exon-1) change showing heterozygous CT and wild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 genotyp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0" name="Group 16"/>
          <p:cNvGrpSpPr/>
          <p:nvPr/>
        </p:nvGrpSpPr>
        <p:grpSpPr>
          <a:xfrm>
            <a:off x="0" y="237600"/>
            <a:ext cx="9144000" cy="4991760"/>
            <a:chOff x="0" y="237600"/>
            <a:chExt cx="9144000" cy="4991760"/>
          </a:xfrm>
        </p:grpSpPr>
        <p:pic>
          <p:nvPicPr>
            <p:cNvPr id="121" name="Picture 11" descr=""/>
            <p:cNvPicPr/>
            <p:nvPr/>
          </p:nvPicPr>
          <p:blipFill>
            <a:blip r:embed="rId1"/>
            <a:stretch/>
          </p:blipFill>
          <p:spPr>
            <a:xfrm>
              <a:off x="1475640" y="521640"/>
              <a:ext cx="5976720" cy="1160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2" name="Rectangle 12"/>
            <p:cNvSpPr/>
            <p:nvPr/>
          </p:nvSpPr>
          <p:spPr>
            <a:xfrm>
              <a:off x="611280" y="237600"/>
              <a:ext cx="85327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98600"/>
                  <a:tab algn="l" pos="474012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C. 1201 G&gt;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398600"/>
                  <a:tab algn="l" pos="474012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          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G/A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                        G/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3" name="Picture 13" descr=""/>
            <p:cNvPicPr/>
            <p:nvPr/>
          </p:nvPicPr>
          <p:blipFill>
            <a:blip r:embed="rId2"/>
            <a:stretch/>
          </p:blipFill>
          <p:spPr>
            <a:xfrm>
              <a:off x="1763640" y="2262240"/>
              <a:ext cx="5729400" cy="122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Rectangle 14"/>
            <p:cNvSpPr/>
            <p:nvPr/>
          </p:nvSpPr>
          <p:spPr>
            <a:xfrm>
              <a:off x="0" y="1852920"/>
              <a:ext cx="77403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6360"/>
                  <a:tab algn="l" pos="431784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      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D. 1222 A&gt;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576360"/>
                  <a:tab algn="l" pos="431784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                                                                  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A/A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                                                 A/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5" name="Picture 15" descr=""/>
            <p:cNvPicPr/>
            <p:nvPr/>
          </p:nvPicPr>
          <p:blipFill>
            <a:blip r:embed="rId3"/>
            <a:stretch/>
          </p:blipFill>
          <p:spPr>
            <a:xfrm>
              <a:off x="1331640" y="3680640"/>
              <a:ext cx="6120720" cy="1548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26" name="TextBox 8"/>
          <p:cNvSpPr/>
          <p:nvPr/>
        </p:nvSpPr>
        <p:spPr>
          <a:xfrm>
            <a:off x="468360" y="5373720"/>
            <a:ext cx="82072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1S: C. Partial electropherogram of 1201 G&gt;A (exon-7) change showing heterozygous GA and wild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G genotyp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.  Partial electropherogram of 1222 A&gt;G (exon-7) change showing wild AA, heterozygous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 and homozygous GG genotyp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Group 4"/>
          <p:cNvGrpSpPr/>
          <p:nvPr/>
        </p:nvGrpSpPr>
        <p:grpSpPr>
          <a:xfrm>
            <a:off x="2987640" y="1268280"/>
            <a:ext cx="3672000" cy="3017880"/>
            <a:chOff x="2987640" y="1268280"/>
            <a:chExt cx="3672000" cy="3017880"/>
          </a:xfrm>
        </p:grpSpPr>
        <p:pic>
          <p:nvPicPr>
            <p:cNvPr id="128" name="Picture 1" descr="C:\Users\m\AppData\Local\Microsoft\Windows\Temporary Internet Files\Content.Word\08-02-2018 SDM.TIF"/>
            <p:cNvPicPr/>
            <p:nvPr/>
          </p:nvPicPr>
          <p:blipFill>
            <a:blip r:embed="rId1"/>
            <a:stretch/>
          </p:blipFill>
          <p:spPr>
            <a:xfrm>
              <a:off x="2987640" y="1700280"/>
              <a:ext cx="3672000" cy="258588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129" name="Rectangle 3"/>
            <p:cNvSpPr/>
            <p:nvPr/>
          </p:nvSpPr>
          <p:spPr>
            <a:xfrm>
              <a:off x="2987640" y="1268280"/>
              <a:ext cx="3600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 </a:t>
              </a:r>
              <a:r>
                <a:rPr b="1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      2     3       4      5      6      7      8</a:t>
              </a:r>
              <a:r>
                <a:rPr b="0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0" name="TextBox 5"/>
          <p:cNvSpPr/>
          <p:nvPr/>
        </p:nvSpPr>
        <p:spPr>
          <a:xfrm>
            <a:off x="684360" y="4581360"/>
            <a:ext cx="7272360" cy="1577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```````````````````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`qqqqqqqqqqqqqqqqqqqqqqqqqqqqqqqqqqqqqqqqqqqqqqqqqqqqqqqqqqqqqqqqqqqqqqqqqqqqqqqqqqqqqqqqqqqqqqqqqqqqqqqqqqqqqqqqqqqqqqqqqqqqqqqqqqqqqqqqqqqqqqqqqqqqqqqqqqqqqqqqqqqqqqqqqqqqqqqqqqqqqqqq``````````````qqqqqqqqqqqqqqqqqqqqqqqqqqqqqqqqqqqqqqqqqqqqqqqqqqqqqqqqqqqq`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``1```````````````````````1`````````````````````````````````````````````````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6"/>
          <p:cNvSpPr/>
          <p:nvPr/>
        </p:nvSpPr>
        <p:spPr>
          <a:xfrm>
            <a:off x="1187280" y="4437000"/>
            <a:ext cx="64090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2S: Agarose gel electrophoretograms indicating the site directed mutagenesis products.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1: 1 kb ladder; Lane-2,3: Mutant 181T&gt;C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4,5: Mutant 1201G&gt;A; Lane-6,7: Mutant 1222A&gt;G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8: Control (without polymerase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Picture 2" descr=""/>
          <p:cNvPicPr/>
          <p:nvPr/>
        </p:nvPicPr>
        <p:blipFill>
          <a:blip r:embed="rId1"/>
          <a:stretch/>
        </p:blipFill>
        <p:spPr>
          <a:xfrm>
            <a:off x="611280" y="257040"/>
            <a:ext cx="7632720" cy="5043600"/>
          </a:xfrm>
          <a:prstGeom prst="rect">
            <a:avLst/>
          </a:prstGeom>
          <a:ln w="0">
            <a:noFill/>
          </a:ln>
        </p:spPr>
      </p:pic>
      <p:sp>
        <p:nvSpPr>
          <p:cNvPr id="133" name="TextBox 2"/>
          <p:cNvSpPr/>
          <p:nvPr/>
        </p:nvSpPr>
        <p:spPr>
          <a:xfrm>
            <a:off x="611280" y="5589720"/>
            <a:ext cx="83534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3S: Partial electropherograms showing the changes introduced by Site Directed Mutagenesis (SDM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17"/>
          <p:cNvSpPr/>
          <p:nvPr/>
        </p:nvSpPr>
        <p:spPr>
          <a:xfrm>
            <a:off x="0" y="907920"/>
            <a:ext cx="43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Group 41"/>
          <p:cNvGrpSpPr/>
          <p:nvPr/>
        </p:nvGrpSpPr>
        <p:grpSpPr>
          <a:xfrm>
            <a:off x="395280" y="981000"/>
            <a:ext cx="8497800" cy="2664000"/>
            <a:chOff x="395280" y="981000"/>
            <a:chExt cx="8497800" cy="2664000"/>
          </a:xfrm>
        </p:grpSpPr>
        <p:pic>
          <p:nvPicPr>
            <p:cNvPr id="53" name="Picture 7" descr="C:\Users\m\Desktop\31-5-17 8R.jpg"/>
            <p:cNvPicPr/>
            <p:nvPr/>
          </p:nvPicPr>
          <p:blipFill>
            <a:blip r:embed="rId1"/>
            <a:srcRect l="7585" t="19883" r="11207" b="0"/>
            <a:stretch/>
          </p:blipFill>
          <p:spPr>
            <a:xfrm>
              <a:off x="395280" y="1413000"/>
              <a:ext cx="3312720" cy="2232000"/>
            </a:xfrm>
            <a:prstGeom prst="rect">
              <a:avLst/>
            </a:prstGeom>
            <a:ln w="28440">
              <a:solidFill>
                <a:srgbClr val="000000"/>
              </a:solidFill>
              <a:miter/>
            </a:ln>
          </p:spPr>
        </p:pic>
        <p:sp>
          <p:nvSpPr>
            <p:cNvPr id="54" name="Rectangle 8"/>
            <p:cNvSpPr/>
            <p:nvPr/>
          </p:nvSpPr>
          <p:spPr>
            <a:xfrm>
              <a:off x="395280" y="1053000"/>
              <a:ext cx="3384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  </a:t>
              </a:r>
              <a:r>
                <a:rPr b="1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      1          2          3           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8"/>
            <p:cNvSpPr/>
            <p:nvPr/>
          </p:nvSpPr>
          <p:spPr>
            <a:xfrm>
              <a:off x="4140000" y="1544760"/>
              <a:ext cx="1152000" cy="201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200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345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151b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6" name="Elbow Connector 11"/>
            <p:cNvCxnSpPr/>
            <p:nvPr/>
          </p:nvCxnSpPr>
          <p:spPr>
            <a:xfrm flipV="1">
              <a:off x="1979280" y="1701000"/>
              <a:ext cx="2089800" cy="108036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57" name="Straight Arrow Connector 13"/>
            <p:cNvCxnSpPr/>
            <p:nvPr/>
          </p:nvCxnSpPr>
          <p:spPr>
            <a:xfrm>
              <a:off x="2123640" y="3141720"/>
              <a:ext cx="1872360" cy="288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58" name="Straight Arrow Connector 15"/>
            <p:cNvCxnSpPr/>
            <p:nvPr/>
          </p:nvCxnSpPr>
          <p:spPr>
            <a:xfrm>
              <a:off x="3492000" y="2491920"/>
              <a:ext cx="648360" cy="2163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pic>
          <p:nvPicPr>
            <p:cNvPr id="59" name="Picture 18" descr="C:\Users\m\Desktop\28-6-17 gel 2 n 3(var 3 ).jpg"/>
            <p:cNvPicPr/>
            <p:nvPr/>
          </p:nvPicPr>
          <p:blipFill>
            <a:blip r:embed="rId2"/>
            <a:srcRect l="7531" t="5395" r="10292" b="0"/>
            <a:stretch/>
          </p:blipFill>
          <p:spPr>
            <a:xfrm>
              <a:off x="5508360" y="1413000"/>
              <a:ext cx="3384720" cy="223200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60" name="Rectangle 19"/>
            <p:cNvSpPr/>
            <p:nvPr/>
          </p:nvSpPr>
          <p:spPr>
            <a:xfrm>
              <a:off x="5364360" y="981000"/>
              <a:ext cx="3384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    </a:t>
              </a:r>
              <a:r>
                <a:rPr b="1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       1          2          3           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21"/>
            <p:cNvSpPr/>
            <p:nvPr/>
          </p:nvSpPr>
          <p:spPr>
            <a:xfrm>
              <a:off x="4932360" y="981000"/>
              <a:ext cx="432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2" name="Elbow Connector 34"/>
            <p:cNvCxnSpPr/>
            <p:nvPr/>
          </p:nvCxnSpPr>
          <p:spPr>
            <a:xfrm rot="10800000">
              <a:off x="4715640" y="1701000"/>
              <a:ext cx="1872360" cy="115164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3" name="Elbow Connector 38"/>
            <p:cNvCxnSpPr/>
            <p:nvPr/>
          </p:nvCxnSpPr>
          <p:spPr>
            <a:xfrm flipV="1" rot="10800000">
              <a:off x="5076000" y="3141360"/>
              <a:ext cx="1945440" cy="288000"/>
            </a:xfrm>
            <a:prstGeom prst="bentConnector3">
              <a:avLst>
                <a:gd name="adj1" fmla="val 49990"/>
              </a:avLst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4" name="Elbow Connector 40"/>
            <p:cNvCxnSpPr/>
            <p:nvPr/>
          </p:nvCxnSpPr>
          <p:spPr>
            <a:xfrm flipV="1" rot="10800000">
              <a:off x="4715640" y="2349360"/>
              <a:ext cx="3672720" cy="358920"/>
            </a:xfrm>
            <a:prstGeom prst="bentConnector3">
              <a:avLst>
                <a:gd name="adj1" fmla="val 49995"/>
              </a:avLst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65" name="TextBox 16"/>
          <p:cNvSpPr/>
          <p:nvPr/>
        </p:nvSpPr>
        <p:spPr>
          <a:xfrm>
            <a:off x="324000" y="3933720"/>
            <a:ext cx="410364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2Sa: Agarose gel electrophoretogram indicating the pattern of isoforms in responder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1: Wild-OCT1 (200bp); Lane-2: Isoform-1 (151bp)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3: Isoform-2 (72bp); Lane-4: Isoform-3 (345bp)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M: DNA marker (100bp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2"/>
          <p:cNvSpPr/>
          <p:nvPr/>
        </p:nvSpPr>
        <p:spPr>
          <a:xfrm>
            <a:off x="4932360" y="3933720"/>
            <a:ext cx="403236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2Sb: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arose gel electrophoretogram indicating the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tern of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soforms in  non-responder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1: Wild-OCT1 (200 bp); Lane-2: Isoform-1 (151bp);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3: Isoform-2 (72bp); Lane-4: Isoform-3 (345bp)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ne-M: DNA marker (100bp)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4" name=""/>
          <p:cNvGraphicFramePr/>
          <p:nvPr/>
        </p:nvGraphicFramePr>
        <p:xfrm>
          <a:off x="1476360" y="765000"/>
          <a:ext cx="6335640" cy="2881440"/>
        </p:xfrm>
        <a:graphic>
          <a:graphicData uri="http://schemas.openxmlformats.org/drawingml/2006/table">
            <a:tbl>
              <a:tblPr/>
              <a:tblGrid>
                <a:gridCol w="749160"/>
                <a:gridCol w="3083040"/>
                <a:gridCol w="1154160"/>
                <a:gridCol w="1349280"/>
              </a:tblGrid>
              <a:tr h="624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na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(5ʹ-3ʹ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nhealing temperature (°C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mplicon size (bp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23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CT-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5ʹ-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TTGGCCGAATGGGAATCAC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-5ʹ- CCCAACACCGCAAACAAAAT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°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0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60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sofrom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-5ʹ-GTACCCCACATTCGTCAGCG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-5ʹ-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GGTAAATCGTGTTTTCTTTGGGC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°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1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3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soform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-5ʹ-CCCCACATTCGTCAGGAACC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-5ʹ-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AGGGTTCTGAGGTTTGGACC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°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2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842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sofrom-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5ʹ-GTTGGCCGAATGGGAATCA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-5ʹ-TACAGAGAAGTGAAGGCGTCTA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2°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5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35" name="Rectangle 2"/>
          <p:cNvSpPr/>
          <p:nvPr/>
        </p:nvSpPr>
        <p:spPr>
          <a:xfrm>
            <a:off x="2740320" y="333000"/>
            <a:ext cx="368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1S. Primer sequences for isoform analysi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6" name=""/>
          <p:cNvGraphicFramePr/>
          <p:nvPr/>
        </p:nvGraphicFramePr>
        <p:xfrm>
          <a:off x="1619280" y="476280"/>
          <a:ext cx="5919840" cy="1177920"/>
        </p:xfrm>
        <a:graphic>
          <a:graphicData uri="http://schemas.openxmlformats.org/drawingml/2006/table">
            <a:tbl>
              <a:tblPr/>
              <a:tblGrid>
                <a:gridCol w="876240"/>
                <a:gridCol w="2703600"/>
                <a:gridCol w="1170000"/>
                <a:gridCol w="1170000"/>
              </a:tblGrid>
              <a:tr h="3848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Seque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nhealing temperature (</a:t>
                      </a:r>
                      <a:r>
                        <a:rPr b="1" lang="en-IN" sz="11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duct size (bp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26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PD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prietary information of Thermo Scientif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48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CT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5ʹ-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TTGGCCGAATGGGAATCAC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:5ʹ- CCCAACACCGCAAACAAAAT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9240">
                <a:tc gridSpan="4"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= forward primer; R= reverse primer; T</a:t>
                      </a:r>
                      <a:r>
                        <a:rPr b="1" i="1" lang="en-IN" sz="11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</a:t>
                      </a:r>
                      <a:r>
                        <a:rPr b="1" i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= annealing temperature; bp= base pai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137" name="Rectangle 1"/>
          <p:cNvSpPr/>
          <p:nvPr/>
        </p:nvSpPr>
        <p:spPr>
          <a:xfrm>
            <a:off x="2598840" y="97920"/>
            <a:ext cx="3946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2S.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Primer sequences for OCT-1 and GAPDH qRT-PC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8" name=""/>
          <p:cNvGraphicFramePr/>
          <p:nvPr/>
        </p:nvGraphicFramePr>
        <p:xfrm>
          <a:off x="1633680" y="2536920"/>
          <a:ext cx="5876640" cy="2395440"/>
        </p:xfrm>
        <a:graphic>
          <a:graphicData uri="http://schemas.openxmlformats.org/drawingml/2006/table">
            <a:tbl>
              <a:tblPr/>
              <a:tblGrid>
                <a:gridCol w="699840"/>
                <a:gridCol w="3051360"/>
                <a:gridCol w="1257120"/>
                <a:gridCol w="868320"/>
              </a:tblGrid>
              <a:tr h="54756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sequence (5ʹ-3ʹ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nhealing temperature (</a:t>
                      </a:r>
                      <a:r>
                        <a:rPr b="0" lang="en-IN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</a:t>
                      </a: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mplicon size (bp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N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 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ʹ- ACTTGGTTGCCTTCCAGATGTT-3ʹ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: 5ʹ- AACTCCCATGTTACAGAGGCTT-3ʹ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</a:t>
                      </a:r>
                      <a:r>
                        <a:rPr b="0" lang="en-IN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4b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76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N 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 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ʹ-TTGAAACCTCCTCTTGGCTCAGGT-3ʹ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: 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ʹ- GCCTGGGAAATGATGAAAGCAGAC-3ʹ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r>
                        <a:rPr b="0" lang="en-IN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6b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1400">
                <a:tc gridSpan="4"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= forward primer; R= reverse primer; T</a:t>
                      </a:r>
                      <a:r>
                        <a:rPr b="1" i="1" lang="en-IN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</a:t>
                      </a:r>
                      <a:r>
                        <a:rPr b="1" i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= annealing temperature; bp= base pai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139" name="Rectangle 2"/>
          <p:cNvSpPr/>
          <p:nvPr/>
        </p:nvSpPr>
        <p:spPr>
          <a:xfrm>
            <a:off x="2890440" y="2205360"/>
            <a:ext cx="381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3S. Primer sequences for exon-1 and exon-7 of OCT-1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0" name=""/>
          <p:cNvGraphicFramePr/>
          <p:nvPr/>
        </p:nvGraphicFramePr>
        <p:xfrm>
          <a:off x="1763640" y="404640"/>
          <a:ext cx="5400720" cy="2424240"/>
        </p:xfrm>
        <a:graphic>
          <a:graphicData uri="http://schemas.openxmlformats.org/drawingml/2006/table">
            <a:tbl>
              <a:tblPr/>
              <a:tblGrid>
                <a:gridCol w="1077840"/>
                <a:gridCol w="3245040"/>
                <a:gridCol w="1077840"/>
              </a:tblGrid>
              <a:tr h="5770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na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44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(5ʹ-3ʹ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nhealing temperature (°C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22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61C (181C&gt;T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: 5ʹ-TGAGCTGAGCCAG</a:t>
                      </a:r>
                      <a:r>
                        <a:rPr b="0" lang="en-IN" sz="1100" spc="-1" strike="noStrike">
                          <a:solidFill>
                            <a:srgbClr val="ff6600"/>
                          </a:solidFill>
                          <a:latin typeface="Times New Roman"/>
                          <a:ea typeface="Calibri"/>
                        </a:rPr>
                        <a:t>T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CTGTGGCTGGAG-3ʹ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: 5’-CTCCAGCCACAGC</a:t>
                      </a:r>
                      <a:r>
                        <a:rPr b="0" lang="en-IN" sz="1100" spc="-1" strike="noStrike">
                          <a:solidFill>
                            <a:srgbClr val="ff6600"/>
                          </a:solidFill>
                          <a:latin typeface="Times New Roman"/>
                          <a:ea typeface="Calibri"/>
                        </a:rPr>
                        <a:t>A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TGGCTCAGCTCA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449280"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°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87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401S (1201 G&gt;A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142236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: 5ʹ-ATTGACCGCGTG</a:t>
                      </a:r>
                      <a:r>
                        <a:rPr b="0" lang="en-IN" sz="1100" spc="-1" strike="noStrike">
                          <a:solidFill>
                            <a:srgbClr val="ff6600"/>
                          </a:solidFill>
                          <a:latin typeface="Times New Roman"/>
                          <a:ea typeface="Calibri"/>
                        </a:rPr>
                        <a:t>A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CCGCATCTACC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142236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: 5’-GGGTAGATGCGGC</a:t>
                      </a:r>
                      <a:r>
                        <a:rPr b="0" lang="en-IN" sz="1100" spc="-1" strike="noStrike">
                          <a:solidFill>
                            <a:srgbClr val="ff6600"/>
                          </a:solidFill>
                          <a:latin typeface="Times New Roman"/>
                          <a:ea typeface="Calibri"/>
                        </a:rPr>
                        <a:t>T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CGCGGTCAAT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449280"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°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22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408V (1222 A&gt;G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: 5’-ACCCCATGGCC</a:t>
                      </a:r>
                      <a:r>
                        <a:rPr b="0" lang="en-IN" sz="1100" spc="-1" strike="noStrike">
                          <a:solidFill>
                            <a:srgbClr val="ff6600"/>
                          </a:solidFill>
                          <a:latin typeface="Times New Roman"/>
                          <a:ea typeface="Calibri"/>
                        </a:rPr>
                        <a:t>G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GTCAAATTTGTTG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: 5’-CAACAAATTTGACA</a:t>
                      </a:r>
                      <a:r>
                        <a:rPr b="0" lang="en-IN" sz="1100" spc="-1" strike="noStrike">
                          <a:solidFill>
                            <a:srgbClr val="ff6600"/>
                          </a:solidFill>
                          <a:latin typeface="Times New Roman"/>
                          <a:ea typeface="Calibri"/>
                        </a:rPr>
                        <a:t>C</a:t>
                      </a: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GCCATGGGGT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449280"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°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1280">
                <a:tc gridSpan="3">
                  <a:txBody>
                    <a:bodyPr lIns="68760" rIns="68760" tIns="0" bIns="0" anchor="t">
                      <a:noAutofit/>
                    </a:bodyPr>
                    <a:p>
                      <a:pPr marL="449280"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: Forward Primer; R: Reverse Prim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141" name="Rectangle 1"/>
          <p:cNvSpPr/>
          <p:nvPr/>
        </p:nvSpPr>
        <p:spPr>
          <a:xfrm>
            <a:off x="3048120" y="97920"/>
            <a:ext cx="3047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223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4S. Primers for site directed mutagenesis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Rectangle 1"/>
          <p:cNvSpPr/>
          <p:nvPr/>
        </p:nvSpPr>
        <p:spPr>
          <a:xfrm>
            <a:off x="2440800" y="97920"/>
            <a:ext cx="4262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63392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5S: The clinical parameters of responders vs. non-responder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3" name=""/>
          <p:cNvGraphicFramePr/>
          <p:nvPr/>
        </p:nvGraphicFramePr>
        <p:xfrm>
          <a:off x="826920" y="366840"/>
          <a:ext cx="7417080" cy="4532040"/>
        </p:xfrm>
        <a:graphic>
          <a:graphicData uri="http://schemas.openxmlformats.org/drawingml/2006/table">
            <a:tbl>
              <a:tblPr/>
              <a:tblGrid>
                <a:gridCol w="2745000"/>
                <a:gridCol w="1593720"/>
                <a:gridCol w="2162160"/>
                <a:gridCol w="916200"/>
              </a:tblGrid>
              <a:tr h="4046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aramet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esponder (n=2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on-respond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</a:t>
                      </a: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(n=16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-valu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27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end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816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5 (60.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816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10 (40.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8 (50.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10205"/>
                          </a:solidFill>
                          <a:latin typeface="Times New Roman"/>
                          <a:ea typeface="Calibri"/>
                        </a:rPr>
                        <a:t>8 (50.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 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ge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Years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0.04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.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6.81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.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Weight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(kgs) 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69.72±10.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68.5±10.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MI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kg/m</a:t>
                      </a:r>
                      <a:r>
                        <a:rPr b="0" lang="en-IN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) 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6.56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5.88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BS (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g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19.30±23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58.87±46.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lt;0.0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PG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mg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61.42±41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00.81±6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l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Gs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mg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81.96±78.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15.93±68.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C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md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71.08±31.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98.44±43.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l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DL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(mg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4.08±7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6.81±9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LDL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(mg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08.37±32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24.55±38.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Uric acid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mg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.67±1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.92±0.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l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ilirubin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(mg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80±0.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98±0.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LT 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(u/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0.2±15.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1.12±27.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ST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u/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1.2±21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3.75±24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LP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u/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23.96±29.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24.41±25.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reatinine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(mg/dL) Mean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91±0.1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0.76±0.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l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T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4 (5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 (5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PI</a:t>
                      </a: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</a:t>
                      </a: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intak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 (1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 (5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l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tatin intak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0 (4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 (25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44" name="Rectangle 2"/>
          <p:cNvSpPr/>
          <p:nvPr/>
        </p:nvSpPr>
        <p:spPr>
          <a:xfrm>
            <a:off x="693720" y="4907160"/>
            <a:ext cx="75614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922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Calibri"/>
              </a:rPr>
              <a:t>BMI: Basal metabolic index; FBS: Fasting blood sugar; PPG: Post-prandial gluscose; TGs: Triglycerides; TC: Total cholesterol; HDL: High density lipoprotein; LDL: Low density lipoprotein; ALT: Alanine aminotransferase; AST: Aspartate aminotransferase; ALP: Alkaline phosphatase; HTN: Hypertension; PPI: Proton pump inhibitors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Box 2"/>
          <p:cNvSpPr/>
          <p:nvPr/>
        </p:nvSpPr>
        <p:spPr>
          <a:xfrm>
            <a:off x="1940040" y="907920"/>
            <a:ext cx="579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6S: Levels of HbA1C pre and post metformi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6" name=""/>
          <p:cNvGraphicFramePr/>
          <p:nvPr/>
        </p:nvGraphicFramePr>
        <p:xfrm>
          <a:off x="2073240" y="1268280"/>
          <a:ext cx="5527800" cy="924120"/>
        </p:xfrm>
        <a:graphic>
          <a:graphicData uri="http://schemas.openxmlformats.org/drawingml/2006/table">
            <a:tbl>
              <a:tblPr/>
              <a:tblGrid>
                <a:gridCol w="1467000"/>
                <a:gridCol w="1466640"/>
                <a:gridCol w="1616040"/>
                <a:gridCol w="978120"/>
              </a:tblGrid>
              <a:tr h="1753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bA1C (%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esponder (n=2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on-responder (n=1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46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e-treat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8.13 </a:t>
                      </a: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1.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8.10 </a:t>
                      </a: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1.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gt; 0.0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53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ost-treat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6.19  </a:t>
                      </a: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0.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9.33 </a:t>
                      </a: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1.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lt;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88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ean % chan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-1.94 </a:t>
                      </a: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1.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1.23 </a:t>
                      </a: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en-IN" sz="1000" spc="-1" strike="noStrike">
                          <a:solidFill>
                            <a:srgbClr val="010204"/>
                          </a:solidFill>
                          <a:latin typeface="Times New Roman"/>
                          <a:ea typeface="Times New Roman"/>
                        </a:rPr>
                        <a:t>1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59040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&lt;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TextBox 1"/>
          <p:cNvSpPr/>
          <p:nvPr/>
        </p:nvSpPr>
        <p:spPr>
          <a:xfrm>
            <a:off x="1206360" y="85680"/>
            <a:ext cx="673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7S: Multivariate analysis of metformin response in relation to confounding factor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8" name=""/>
          <p:cNvGraphicFramePr/>
          <p:nvPr/>
        </p:nvGraphicFramePr>
        <p:xfrm>
          <a:off x="2735280" y="333360"/>
          <a:ext cx="3673440" cy="744480"/>
        </p:xfrm>
        <a:graphic>
          <a:graphicData uri="http://schemas.openxmlformats.org/drawingml/2006/table">
            <a:tbl>
              <a:tblPr/>
              <a:tblGrid>
                <a:gridCol w="851040"/>
                <a:gridCol w="1046160"/>
                <a:gridCol w="1046160"/>
                <a:gridCol w="730080"/>
              </a:tblGrid>
              <a:tr h="203400">
                <a:tc gridSpan="4">
                  <a:txBody>
                    <a:bodyPr lIns="68760" rIns="6876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etween-Subjects Factor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3400">
                <a:tc gridSpan="2"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alue Labe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rowSpan="2">
                  <a:txBody>
                    <a:bodyPr lIns="68760" rIns="6876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SPON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spond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-respond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49" name=""/>
          <p:cNvGraphicFramePr/>
          <p:nvPr/>
        </p:nvGraphicFramePr>
        <p:xfrm>
          <a:off x="755640" y="1125360"/>
          <a:ext cx="7993080" cy="5146920"/>
        </p:xfrm>
        <a:graphic>
          <a:graphicData uri="http://schemas.openxmlformats.org/drawingml/2006/table">
            <a:tbl>
              <a:tblPr/>
              <a:tblGrid>
                <a:gridCol w="1490760"/>
                <a:gridCol w="1261800"/>
                <a:gridCol w="695520"/>
                <a:gridCol w="966600"/>
                <a:gridCol w="968400"/>
                <a:gridCol w="675000"/>
                <a:gridCol w="966600"/>
                <a:gridCol w="968400"/>
              </a:tblGrid>
              <a:tr h="203400">
                <a:tc gridSpan="8">
                  <a:txBody>
                    <a:bodyPr lIns="30600" rIns="3060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ltivariate T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06440">
                <a:tc gridSpan="2"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ffe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othesis d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rror d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g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ct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rtial Eta Squar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rowSpan="4"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ercep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llai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2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241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2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ks' Lamb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241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2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telling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241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2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y's Largest 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241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2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rowSpan="4"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llai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69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ks' Lamb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9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69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telling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69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y's Largest 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69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rowSpan="4"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slipidem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llai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315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ks' Lamb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9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315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telling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315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y's Largest 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315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rowSpan="4"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onpumpinhibito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llai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1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330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1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ks' Lamb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8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330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1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telling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1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330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1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y's Largest 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1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330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1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rowSpan="4"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yperuricem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llai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323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ks' Lamb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9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323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telling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323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y's Largest 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323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7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rowSpan="4"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SPO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llai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355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ks' Lamb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5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355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otelling's Tra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9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355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y's Largest Roo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9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355</a:t>
                      </a:r>
                      <a:r>
                        <a:rPr b="0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600" rIns="30600" tIns="0" bIns="0" anchor="t">
                      <a:noAutofit/>
                    </a:bodyPr>
                    <a:p>
                      <a:pPr marL="38160" algn="r">
                        <a:lnSpc>
                          <a:spcPts val="15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4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600" marR="30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50" name="Picture 9" descr=""/>
          <p:cNvPicPr/>
          <p:nvPr/>
        </p:nvPicPr>
        <p:blipFill>
          <a:blip r:embed="rId1"/>
          <a:stretch/>
        </p:blipFill>
        <p:spPr>
          <a:xfrm>
            <a:off x="755640" y="6286680"/>
            <a:ext cx="7993080" cy="74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1" name=""/>
          <p:cNvGraphicFramePr/>
          <p:nvPr/>
        </p:nvGraphicFramePr>
        <p:xfrm>
          <a:off x="2268360" y="692280"/>
          <a:ext cx="5112000" cy="3063600"/>
        </p:xfrm>
        <a:graphic>
          <a:graphicData uri="http://schemas.openxmlformats.org/drawingml/2006/table">
            <a:tbl>
              <a:tblPr/>
              <a:tblGrid>
                <a:gridCol w="687600"/>
                <a:gridCol w="884160"/>
                <a:gridCol w="789120"/>
                <a:gridCol w="687240"/>
                <a:gridCol w="982800"/>
                <a:gridCol w="1081080"/>
              </a:tblGrid>
              <a:tr h="5112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luster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ull fitnes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Delta 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ner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-Bonds (all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-Bond Ligand Atom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2.49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5.58279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32.84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1.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5.85695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29.99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4.54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5.69970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34.94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5.44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5.76519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35.2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4.5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5.64538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32.55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4.6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5.6592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32.60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416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5.89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6.5291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34.07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24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5.97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6.5361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34.08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38.70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6.50842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40.23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1444.51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6.70447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-42.85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52" name="Rectangle 2"/>
          <p:cNvSpPr/>
          <p:nvPr/>
        </p:nvSpPr>
        <p:spPr>
          <a:xfrm>
            <a:off x="1281240" y="459360"/>
            <a:ext cx="65815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8S. Docking parameters of the metformin-OCT1 cluster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3" name="Picture 2" descr=""/>
          <p:cNvPicPr/>
          <p:nvPr/>
        </p:nvPicPr>
        <p:blipFill>
          <a:blip r:embed="rId1"/>
          <a:stretch/>
        </p:blipFill>
        <p:spPr>
          <a:xfrm>
            <a:off x="2411280" y="4076640"/>
            <a:ext cx="5865840" cy="5256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54" name=""/>
          <p:cNvGraphicFramePr/>
          <p:nvPr/>
        </p:nvGraphicFramePr>
        <p:xfrm>
          <a:off x="2124000" y="4508640"/>
          <a:ext cx="5869080" cy="1406520"/>
        </p:xfrm>
        <a:graphic>
          <a:graphicData uri="http://schemas.openxmlformats.org/drawingml/2006/table">
            <a:tbl>
              <a:tblPr/>
              <a:tblGrid>
                <a:gridCol w="1467000"/>
                <a:gridCol w="1466640"/>
                <a:gridCol w="1467000"/>
                <a:gridCol w="1468440"/>
              </a:tblGrid>
              <a:tr h="4773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tient grou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±S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. of subjec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73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spond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1±0.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73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-respond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4±0.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 5"/>
          <p:cNvGrpSpPr/>
          <p:nvPr/>
        </p:nvGrpSpPr>
        <p:grpSpPr>
          <a:xfrm>
            <a:off x="395280" y="692280"/>
            <a:ext cx="8064360" cy="4249080"/>
            <a:chOff x="395280" y="692280"/>
            <a:chExt cx="8064360" cy="4249080"/>
          </a:xfrm>
        </p:grpSpPr>
        <p:pic>
          <p:nvPicPr>
            <p:cNvPr id="68" name="Picture 1" descr=""/>
            <p:cNvPicPr/>
            <p:nvPr/>
          </p:nvPicPr>
          <p:blipFill>
            <a:blip r:embed="rId1"/>
            <a:stretch/>
          </p:blipFill>
          <p:spPr>
            <a:xfrm>
              <a:off x="1043280" y="692280"/>
              <a:ext cx="7344360" cy="11804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69" name="Picture 2" descr="C:\Users\m\Desktop\Untitled 1.jpg"/>
            <p:cNvPicPr/>
            <p:nvPr/>
          </p:nvPicPr>
          <p:blipFill>
            <a:blip r:embed="rId2"/>
            <a:stretch/>
          </p:blipFill>
          <p:spPr>
            <a:xfrm>
              <a:off x="1043280" y="2049840"/>
              <a:ext cx="7344360" cy="12913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70" name="Picture 3" descr="C:\Users\m\Desktop\Untitled 3.jpg"/>
            <p:cNvPicPr/>
            <p:nvPr/>
          </p:nvPicPr>
          <p:blipFill>
            <a:blip r:embed="rId3"/>
            <a:stretch/>
          </p:blipFill>
          <p:spPr>
            <a:xfrm>
              <a:off x="1043280" y="3525120"/>
              <a:ext cx="7416360" cy="14162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71" name="TextBox 4"/>
            <p:cNvSpPr/>
            <p:nvPr/>
          </p:nvSpPr>
          <p:spPr>
            <a:xfrm>
              <a:off x="395280" y="869040"/>
              <a:ext cx="432000" cy="338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N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IN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TextBox 6"/>
          <p:cNvSpPr/>
          <p:nvPr/>
        </p:nvSpPr>
        <p:spPr>
          <a:xfrm>
            <a:off x="900000" y="5229360"/>
            <a:ext cx="7632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3S: Partial electropherogram showing :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 The wild OCT-1 sequence.; b. The isoform-1 sequence; c. The isoform-3 sequenc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1" descr=""/>
          <p:cNvPicPr/>
          <p:nvPr/>
        </p:nvPicPr>
        <p:blipFill>
          <a:blip r:embed="rId1"/>
          <a:stretch/>
        </p:blipFill>
        <p:spPr>
          <a:xfrm>
            <a:off x="611280" y="765000"/>
            <a:ext cx="7561080" cy="4464360"/>
          </a:xfrm>
          <a:prstGeom prst="rect">
            <a:avLst/>
          </a:prstGeom>
          <a:ln w="0">
            <a:noFill/>
          </a:ln>
        </p:spPr>
      </p:pic>
      <p:sp>
        <p:nvSpPr>
          <p:cNvPr id="74" name="TextBox 2"/>
          <p:cNvSpPr/>
          <p:nvPr/>
        </p:nvSpPr>
        <p:spPr>
          <a:xfrm>
            <a:off x="684360" y="5084640"/>
            <a:ext cx="763272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4S: Multiple sequence alignment of full length OCT-1, isoform-1, isoform-2, isoform-3 and OCT-1 amplification product (red).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sequence of OCT-1 amplified product (200bp) perfectly aligned with the full length OCT-1 cDNA sequence from position 1455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 1655 (highlighted sequences in grey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AutoShape 2"/>
          <p:cNvSpPr/>
          <p:nvPr/>
        </p:nvSpPr>
        <p:spPr>
          <a:xfrm>
            <a:off x="684360" y="-819000"/>
            <a:ext cx="7561080" cy="604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1" descr=""/>
          <p:cNvPicPr/>
          <p:nvPr/>
        </p:nvPicPr>
        <p:blipFill>
          <a:blip r:embed="rId1"/>
          <a:stretch/>
        </p:blipFill>
        <p:spPr>
          <a:xfrm>
            <a:off x="611280" y="333360"/>
            <a:ext cx="7993080" cy="5040360"/>
          </a:xfrm>
          <a:prstGeom prst="rect">
            <a:avLst/>
          </a:prstGeom>
          <a:ln w="0">
            <a:noFill/>
          </a:ln>
        </p:spPr>
      </p:pic>
      <p:sp>
        <p:nvSpPr>
          <p:cNvPr id="77" name="TextBox 2"/>
          <p:cNvSpPr/>
          <p:nvPr/>
        </p:nvSpPr>
        <p:spPr>
          <a:xfrm>
            <a:off x="684360" y="5300640"/>
            <a:ext cx="81356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5S: Multiple sequence alignment of full length OCT-1, isoform-1, isoform-2, isoform-3 and iso-1 amplification product (red).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he sequence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f isoform-1 (151bp) fragment perfectly aligned with the isoform-1 cDNA sequence from position 1367 to 1518 (highlighted sequences in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e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1" descr=""/>
          <p:cNvPicPr/>
          <p:nvPr/>
        </p:nvPicPr>
        <p:blipFill>
          <a:blip r:embed="rId1"/>
          <a:stretch/>
        </p:blipFill>
        <p:spPr>
          <a:xfrm>
            <a:off x="395280" y="0"/>
            <a:ext cx="8137440" cy="6597720"/>
          </a:xfrm>
          <a:prstGeom prst="rect">
            <a:avLst/>
          </a:prstGeom>
          <a:ln w="0">
            <a:noFill/>
          </a:ln>
        </p:spPr>
      </p:pic>
      <p:sp>
        <p:nvSpPr>
          <p:cNvPr id="79" name="TextBox 5"/>
          <p:cNvSpPr/>
          <p:nvPr/>
        </p:nvSpPr>
        <p:spPr>
          <a:xfrm>
            <a:off x="0" y="6381720"/>
            <a:ext cx="914400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</a:t>
            </a:r>
            <a:r>
              <a:rPr b="1" lang="en-IN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6S: Multiple sequence alignment of full length OCT-1, isoform-1, isoform-2, isoform-3 and iso-3 amplification product (red).</a:t>
            </a:r>
            <a:r>
              <a:rPr b="0" i="1" lang="en-IN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IN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</a:t>
            </a:r>
            <a:r>
              <a:rPr b="0" i="1" lang="en-IN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sequence of isoform-3 (345bp) fragment</a:t>
            </a:r>
            <a:r>
              <a:rPr b="0" lang="en-IN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i="1" lang="en-IN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igned with the  isoform-3 cDNA sequence from position 1093 to 1438 (highlighted sequences in grey)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Picture 3" descr=""/>
          <p:cNvPicPr/>
          <p:nvPr/>
        </p:nvPicPr>
        <p:blipFill>
          <a:blip r:embed="rId1"/>
          <a:stretch/>
        </p:blipFill>
        <p:spPr>
          <a:xfrm>
            <a:off x="1835280" y="549360"/>
            <a:ext cx="4897440" cy="4967280"/>
          </a:xfrm>
          <a:prstGeom prst="rect">
            <a:avLst/>
          </a:prstGeom>
          <a:ln w="0">
            <a:noFill/>
          </a:ln>
        </p:spPr>
      </p:pic>
      <p:cxnSp>
        <p:nvCxnSpPr>
          <p:cNvPr id="81" name="AutoShape 2"/>
          <p:cNvCxnSpPr/>
          <p:nvPr/>
        </p:nvCxnSpPr>
        <p:spPr>
          <a:xfrm>
            <a:off x="3634920" y="1483920"/>
            <a:ext cx="23054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82" name="Straight Connector 19"/>
          <p:cNvSpPr/>
          <p:nvPr/>
        </p:nvSpPr>
        <p:spPr>
          <a:xfrm>
            <a:off x="3635280" y="1268280"/>
            <a:ext cx="0" cy="432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28"/>
          <p:cNvSpPr/>
          <p:nvPr/>
        </p:nvSpPr>
        <p:spPr>
          <a:xfrm>
            <a:off x="5940360" y="1268280"/>
            <a:ext cx="0" cy="432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38"/>
          <p:cNvSpPr/>
          <p:nvPr/>
        </p:nvSpPr>
        <p:spPr>
          <a:xfrm>
            <a:off x="3708360" y="907920"/>
            <a:ext cx="21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1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value: &gt;0.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7"/>
          <p:cNvSpPr/>
          <p:nvPr/>
        </p:nvSpPr>
        <p:spPr>
          <a:xfrm>
            <a:off x="1619280" y="5589720"/>
            <a:ext cx="64818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 7S: Dot plot showing relative OCT-1 mRNA expression levels in responders vs. non- responders.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CT-1 mRNA expression in responders (n = 15) and non-responders (n = 15) was determined b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analysis. Relative quantification of OCT-1 mRNA expression was normalized to GAPDH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ousekeeping gen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3" descr=""/>
          <p:cNvPicPr/>
          <p:nvPr/>
        </p:nvPicPr>
        <p:blipFill>
          <a:blip r:embed="rId1"/>
          <a:stretch/>
        </p:blipFill>
        <p:spPr>
          <a:xfrm>
            <a:off x="4572000" y="260280"/>
            <a:ext cx="8353440" cy="3168720"/>
          </a:xfrm>
          <a:prstGeom prst="rect">
            <a:avLst/>
          </a:prstGeom>
          <a:ln w="0">
            <a:noFill/>
          </a:ln>
        </p:spPr>
      </p:pic>
      <p:grpSp>
        <p:nvGrpSpPr>
          <p:cNvPr id="87" name="Group 7"/>
          <p:cNvGrpSpPr/>
          <p:nvPr/>
        </p:nvGrpSpPr>
        <p:grpSpPr>
          <a:xfrm>
            <a:off x="324000" y="-316080"/>
            <a:ext cx="9504360" cy="6583680"/>
            <a:chOff x="324000" y="-316080"/>
            <a:chExt cx="9504360" cy="6583680"/>
          </a:xfrm>
        </p:grpSpPr>
        <p:pic>
          <p:nvPicPr>
            <p:cNvPr id="88" name="Picture 1" descr=""/>
            <p:cNvPicPr/>
            <p:nvPr/>
          </p:nvPicPr>
          <p:blipFill>
            <a:blip r:embed="rId2"/>
            <a:stretch/>
          </p:blipFill>
          <p:spPr>
            <a:xfrm>
              <a:off x="324000" y="-316080"/>
              <a:ext cx="7920360" cy="372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5" descr=""/>
            <p:cNvPicPr/>
            <p:nvPr/>
          </p:nvPicPr>
          <p:blipFill>
            <a:blip r:embed="rId3"/>
            <a:stretch/>
          </p:blipFill>
          <p:spPr>
            <a:xfrm>
              <a:off x="2988000" y="3572640"/>
              <a:ext cx="6840360" cy="2694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0" name="TextBox 5"/>
          <p:cNvSpPr/>
          <p:nvPr/>
        </p:nvSpPr>
        <p:spPr>
          <a:xfrm>
            <a:off x="395280" y="6165720"/>
            <a:ext cx="842472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8S: A. Lateral view of OCT-1 model; B.  Top view of OCT-1 model. </a:t>
            </a: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ange helix corresponds to exon-1; Magenta helix corresponds to exon-7; The extracellular region (yellow dotted circle) and the cytoplasmic region (black dotted circle) is  shown in the figure A.  C. 3D structure of metformi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Picture 1" descr=""/>
          <p:cNvPicPr/>
          <p:nvPr/>
        </p:nvPicPr>
        <p:blipFill>
          <a:blip r:embed="rId1"/>
          <a:stretch/>
        </p:blipFill>
        <p:spPr>
          <a:xfrm>
            <a:off x="755640" y="981000"/>
            <a:ext cx="7920000" cy="4248360"/>
          </a:xfrm>
          <a:prstGeom prst="rect">
            <a:avLst/>
          </a:prstGeom>
          <a:ln w="0">
            <a:noFill/>
          </a:ln>
        </p:spPr>
      </p:pic>
      <p:sp>
        <p:nvSpPr>
          <p:cNvPr id="92" name="TextBox 2"/>
          <p:cNvSpPr/>
          <p:nvPr/>
        </p:nvSpPr>
        <p:spPr>
          <a:xfrm>
            <a:off x="900000" y="5373720"/>
            <a:ext cx="7848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8S D-E: Docked complexes (yellow dotted circles) dispersed along the OCT-1 structur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30T08:39:31Z</dcterms:created>
  <dc:creator>My notebook</dc:creator>
  <dc:description/>
  <dc:language>en-US</dc:language>
  <cp:lastModifiedBy>Fizalah Kawoosa</cp:lastModifiedBy>
  <dcterms:modified xsi:type="dcterms:W3CDTF">2022-03-31T06:58:43Z</dcterms:modified>
  <cp:revision>98</cp:revision>
  <dc:subject/>
  <dc:title>Slide 1</dc:title>
</cp:coreProperties>
</file>